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BBF1868-A1AF-4E2D-8486-865428A7D6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8611D45-D579-4544-A64D-009090EF44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F4C563F-DCF6-41D6-8803-A2ADFE717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65B2C55-66C6-4494-9514-9AB532CEF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8FAD004-9FCA-4839-AF99-8D181FCB1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4673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3EFF44-5F71-4B24-8CF1-B830343D53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8A3952EB-2EBA-42DD-86D6-EE9083AE1D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E4193AE-204F-453A-A275-A63201E90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9AA2B6F-A608-4108-A5B4-617693622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6290C35-A17D-46D4-A735-E1D314F79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74925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ED4353B-6DCD-4541-8286-A467372295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7FB7025-5F77-4DEE-AA7B-93127FC17D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B381D3A-38A3-4590-A71B-8C738A599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A7A9EA8-14D9-45CB-B0CB-F4CC88C4D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4BEEB0D-7F18-410E-AB58-63E404A97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40513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BF1C39-3F88-4312-87E0-6BB44280B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3307B130-0A1B-4AC5-973A-8402D080CE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EAB7707-0037-4EB0-8038-19BBE284A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445E9CD-F825-4B81-A773-EC7F10B0A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22B7E67-AED4-44C8-80C2-A6DF1A80E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32840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2A8E93-CF85-432A-8F44-C59C53A7F8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9FF9A9D-11E9-419E-A449-5AA47AD578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31FA49F-47FF-4442-A670-7B65391EF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C66B1FA-E557-4E08-A2DE-D0B76624A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6849157-FF7E-445D-95D1-B97EABB9B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08192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0C6596-C616-44AE-A435-D2BA757E4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9F9BA7B-2118-45F0-A57C-26D8DE45B6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C8A76683-9719-483D-9324-0772FA2081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C190110-9A6D-4B23-8344-DE6F0889F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38FA35A-381B-4972-A586-8261FEEA0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18F4DF7-3901-4B9E-80B7-A413A29D5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96846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D9B6B2-EA66-47B2-BD0F-BFCE040F4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0B86A69-D000-4A20-921A-EB1281F6B8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88F8FCBF-601E-4600-B1C2-9D4DEE6D41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41756A18-D610-4425-BFC2-93D1D0DDCC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CE95963C-CAB1-4B6C-AF90-7832F98807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A9AA99DB-7C03-4D79-8CCC-6B5E6347C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F3B5CCE8-0BD3-4D8B-A1D0-B71101285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842C7970-A72A-44CF-A5E9-AE91B4F2F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7300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C24AEC-3345-4C30-A248-A8C458C122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B647C822-ED4C-48EB-9193-76D418932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A01F8935-1350-419B-9210-C4250CE5A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FBEE4A3F-E912-4A32-9937-7967CBB0A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24351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3CA65846-FE7E-4968-BF32-A69E0BCE8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A868D971-9FE5-4BC1-AF09-78FD0A0C9C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E24C9327-ADE8-4948-BCD7-681677E06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04838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1B3CD9F-2BFE-4487-BC3F-B74B35005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D5C484EA-0589-4C22-A540-F81E844965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B5FF50C9-C420-4191-A981-DAF0506465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CF06337-47B5-4F59-8292-3FB666C23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B9C64FB-12D4-4659-BAD1-4005F0372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7F5DE65-1C42-4430-9F54-B0FD26925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47749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F3AC426-2736-406F-86B7-1FFC3A4C0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91861EA9-F139-4ECF-B218-A3AD4F4FE8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43EF5340-62FA-43D8-A886-E0575C01F8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0B3C93B-D9CF-4E68-95A8-3D4615F13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6E5241AF-35DC-47F2-83A8-61CB7F8B8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7DC66CDE-3335-45DB-9BFF-F9FAF1917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71622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22F1DEB0-B354-437A-9F0F-7548D0B378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F9519FA-F715-44E0-8DD9-586FCD88A3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70A5220-3820-4D4E-ACD6-20238CA38D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DE1D8-A900-4C44-B3A0-38257B248F70}" type="datetimeFigureOut">
              <a:rPr lang="pt-BR" smtClean="0"/>
              <a:t>23/12/20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F0325CB-58E3-4341-91F2-A4909E80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C704DB6-F0A2-4117-9796-1039C48012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0C332E-2E0A-48B9-A3FE-5FE6C1C3E1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19337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AA7F88D-0111-47C9-BB00-A41E547F00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7413"/>
          <a:stretch/>
        </p:blipFill>
        <p:spPr>
          <a:xfrm>
            <a:off x="768350" y="1619249"/>
            <a:ext cx="4603750" cy="4736697"/>
          </a:xfrm>
          <a:prstGeom prst="rect">
            <a:avLst/>
          </a:prstGeom>
        </p:spPr>
      </p:pic>
      <p:pic>
        <p:nvPicPr>
          <p:cNvPr id="7" name="Imagem 6">
            <a:extLst>
              <a:ext uri="{FF2B5EF4-FFF2-40B4-BE49-F238E27FC236}">
                <a16:creationId xmlns:a16="http://schemas.microsoft.com/office/drawing/2014/main" id="{FFBEC9DE-1605-42FA-893F-665D0B25141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7817" r="24939"/>
          <a:stretch/>
        </p:blipFill>
        <p:spPr>
          <a:xfrm>
            <a:off x="5921047" y="2609849"/>
            <a:ext cx="5002972" cy="3679421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1A219546-545F-47FE-A460-8A911445B56C}"/>
              </a:ext>
            </a:extLst>
          </p:cNvPr>
          <p:cNvSpPr txBox="1"/>
          <p:nvPr/>
        </p:nvSpPr>
        <p:spPr>
          <a:xfrm>
            <a:off x="1095374" y="673864"/>
            <a:ext cx="10233025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/>
              <a:t>Supplementary Figure S2 </a:t>
            </a:r>
            <a:r>
              <a:rPr lang="en-US" sz="1600" dirty="0"/>
              <a:t>- The single mutant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A</a:t>
            </a:r>
            <a:r>
              <a:rPr lang="en-US" sz="1600" dirty="0"/>
              <a:t> and the double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A</a:t>
            </a:r>
            <a:r>
              <a:rPr lang="en-US" sz="1600" i="1" dirty="0"/>
              <a:t>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C</a:t>
            </a:r>
            <a:r>
              <a:rPr lang="en-US" sz="1600" dirty="0"/>
              <a:t>,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A</a:t>
            </a:r>
            <a:r>
              <a:rPr lang="en-US" sz="1600" i="1" dirty="0"/>
              <a:t>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C</a:t>
            </a:r>
            <a:r>
              <a:rPr lang="en-US" sz="1600" dirty="0"/>
              <a:t>,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B</a:t>
            </a:r>
            <a:r>
              <a:rPr lang="en-US" sz="1600" i="1" dirty="0"/>
              <a:t>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C</a:t>
            </a:r>
            <a:r>
              <a:rPr lang="en-US" sz="1600" dirty="0"/>
              <a:t> and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B</a:t>
            </a:r>
            <a:r>
              <a:rPr lang="en-US" sz="1600" i="1" dirty="0"/>
              <a:t> </a:t>
            </a:r>
            <a:r>
              <a:rPr lang="el-GR" sz="1600" dirty="0"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en-US" sz="1600" i="1" dirty="0" err="1"/>
              <a:t>atfD</a:t>
            </a:r>
            <a:r>
              <a:rPr lang="en-US" sz="1600" i="1" dirty="0"/>
              <a:t> </a:t>
            </a:r>
            <a:r>
              <a:rPr lang="en-US" sz="1600" dirty="0"/>
              <a:t>mutants showed a reduction in dry weight </a:t>
            </a:r>
            <a:r>
              <a:rPr lang="en-US" sz="1600" dirty="0" smtClean="0"/>
              <a:t>when compared with the </a:t>
            </a:r>
            <a:r>
              <a:rPr lang="en-US" sz="1600" dirty="0"/>
              <a:t>wild-type </a:t>
            </a:r>
            <a:r>
              <a:rPr lang="en-US" sz="1600" b="1" dirty="0"/>
              <a:t>(A and B)</a:t>
            </a:r>
            <a:r>
              <a:rPr lang="en-US" sz="1600" dirty="0"/>
              <a:t>. The strains were grown in MM + 1% glucose for 48 hours under agitation. Mycelia were filtered, lyophilized and subsequently weighed. The results are the means of 3 repetitions for each strain ± standard deviation. The data were analyzed using (Prism, GraphPad) "Two-way ANOVA" followed by "Bonferroni post-tests". The significance levels were *p &lt;0.1; **p &lt;0.01 and ***p &lt;0.001 compared to the wild-type strain.</a:t>
            </a:r>
            <a:endParaRPr lang="pt-BR" sz="1600" dirty="0"/>
          </a:p>
        </p:txBody>
      </p:sp>
    </p:spTree>
    <p:extLst>
      <p:ext uri="{BB962C8B-B14F-4D97-AF65-F5344CB8AC3E}">
        <p14:creationId xmlns:p14="http://schemas.microsoft.com/office/powerpoint/2010/main" val="3334683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3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ilian Pereira</dc:creator>
  <cp:lastModifiedBy>ggoldman</cp:lastModifiedBy>
  <cp:revision>6</cp:revision>
  <dcterms:created xsi:type="dcterms:W3CDTF">2020-07-13T17:51:39Z</dcterms:created>
  <dcterms:modified xsi:type="dcterms:W3CDTF">2020-12-23T19:35:26Z</dcterms:modified>
</cp:coreProperties>
</file>